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2892" y="-84"/>
      </p:cViewPr>
      <p:guideLst>
        <p:guide orient="horz" pos="1577"/>
        <p:guide orient="horz" pos="492"/>
        <p:guide orient="horz" pos="1472"/>
        <p:guide orient="horz" pos="2325"/>
        <p:guide orient="horz" pos="1580"/>
        <p:guide orient="horz" pos="493"/>
        <p:guide pos="1743"/>
        <p:guide pos="210"/>
        <p:guide pos="1739"/>
        <p:guide pos="2161"/>
        <p:guide pos="174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wcl-02\Fachablage\NG2\Doktoranden\Weissm&#252;ller,%20Sabrina\hu%20mice\Ergebnisse%20hum%20Mice%20mit%20OKT3%20TGN14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wcl-02\Fachablage\NG2\Doktoranden\Weissm&#252;ller,%20Sabrina\hu%20mice\Ergebnisse%20hum%20Mice%20mit%20OKT3%20TGN14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CD45 vor-nach Ak -Blut '!$F$75:$G$75</c:f>
                <c:numCache>
                  <c:formatCode>General</c:formatCode>
                  <c:ptCount val="2"/>
                  <c:pt idx="0">
                    <c:v>6.8101394993054072</c:v>
                  </c:pt>
                  <c:pt idx="1">
                    <c:v>15.6322423215609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D45 vor-nach Ak -Blut '!$F$5:$G$5</c:f>
              <c:strCache>
                <c:ptCount val="2"/>
                <c:pt idx="0">
                  <c:v>before</c:v>
                </c:pt>
                <c:pt idx="1">
                  <c:v>after</c:v>
                </c:pt>
              </c:strCache>
            </c:strRef>
          </c:cat>
          <c:val>
            <c:numRef>
              <c:f>'CD45 vor-nach Ak -Blut '!$F$74:$G$74</c:f>
              <c:numCache>
                <c:formatCode>General</c:formatCode>
                <c:ptCount val="2"/>
                <c:pt idx="0">
                  <c:v>46.940000000000005</c:v>
                </c:pt>
                <c:pt idx="1">
                  <c:v>39.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396672"/>
        <c:axId val="40405248"/>
      </c:barChart>
      <c:catAx>
        <c:axId val="403966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0405248"/>
        <c:crosses val="autoZero"/>
        <c:auto val="1"/>
        <c:lblAlgn val="ctr"/>
        <c:lblOffset val="100"/>
        <c:noMultiLvlLbl val="0"/>
      </c:catAx>
      <c:valAx>
        <c:axId val="4040524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hCD45</a:t>
                </a:r>
                <a:r>
                  <a:rPr lang="en-US" sz="800" b="0" baseline="30000" dirty="0"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800" b="0" dirty="0" smtClean="0">
                    <a:latin typeface="Arial" pitchFamily="34" charset="0"/>
                    <a:cs typeface="Arial" pitchFamily="34" charset="0"/>
                  </a:rPr>
                  <a:t>cells </a:t>
                </a: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0396672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CD45 vor-nach Ak -Blut '!$F$30:$G$30</c:f>
                <c:numCache>
                  <c:formatCode>General</c:formatCode>
                  <c:ptCount val="2"/>
                  <c:pt idx="0">
                    <c:v>10.547263242413191</c:v>
                  </c:pt>
                  <c:pt idx="1">
                    <c:v>11.7585227449223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D45 vor-nach Ak -Blut '!$F$5:$G$5</c:f>
              <c:strCache>
                <c:ptCount val="2"/>
                <c:pt idx="0">
                  <c:v>before</c:v>
                </c:pt>
                <c:pt idx="1">
                  <c:v>after</c:v>
                </c:pt>
              </c:strCache>
            </c:strRef>
          </c:cat>
          <c:val>
            <c:numRef>
              <c:f>'CD45 vor-nach Ak -Blut '!$F$29:$G$29</c:f>
              <c:numCache>
                <c:formatCode>General</c:formatCode>
                <c:ptCount val="2"/>
                <c:pt idx="0">
                  <c:v>53.914285714285718</c:v>
                </c:pt>
                <c:pt idx="1">
                  <c:v>53.0428571428571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473728"/>
        <c:axId val="40475264"/>
      </c:barChart>
      <c:catAx>
        <c:axId val="404737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0475264"/>
        <c:crosses val="autoZero"/>
        <c:auto val="1"/>
        <c:lblAlgn val="ctr"/>
        <c:lblOffset val="100"/>
        <c:noMultiLvlLbl val="0"/>
      </c:catAx>
      <c:valAx>
        <c:axId val="4047526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hCD45</a:t>
                </a:r>
                <a:r>
                  <a:rPr lang="en-US" sz="800" b="0" baseline="30000" dirty="0">
                    <a:latin typeface="Arial" pitchFamily="34" charset="0"/>
                    <a:cs typeface="Arial" pitchFamily="34" charset="0"/>
                  </a:rPr>
                  <a:t>+</a:t>
                </a: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800" b="0" dirty="0" smtClean="0">
                    <a:latin typeface="Arial" pitchFamily="34" charset="0"/>
                    <a:cs typeface="Arial" pitchFamily="34" charset="0"/>
                  </a:rPr>
                  <a:t>cells </a:t>
                </a:r>
                <a:r>
                  <a:rPr lang="en-US" sz="800" b="0" dirty="0">
                    <a:latin typeface="Arial" pitchFamily="34" charset="0"/>
                    <a:cs typeface="Arial" pitchFamily="34" charset="0"/>
                  </a:rPr>
                  <a:t>[%]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40473728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8438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312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4965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9904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932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5837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5573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3241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8282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702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654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E0902-D5B0-42B1-8833-5F2E10C31064}" type="datetimeFigureOut">
              <a:rPr lang="de-DE" smtClean="0"/>
              <a:t>01.0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69AFE-2F6D-46A9-A4D0-C7C3B01D7FD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4956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61" t="15631" b="25783"/>
          <a:stretch/>
        </p:blipFill>
        <p:spPr bwMode="auto">
          <a:xfrm>
            <a:off x="2998603" y="499134"/>
            <a:ext cx="3158027" cy="16128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15" name="Diagramm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487880"/>
              </p:ext>
            </p:extLst>
          </p:nvPr>
        </p:nvGraphicFramePr>
        <p:xfrm>
          <a:off x="244434" y="448563"/>
          <a:ext cx="2020301" cy="1886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0" name="Textfeld 49"/>
          <p:cNvSpPr txBox="1"/>
          <p:nvPr/>
        </p:nvSpPr>
        <p:spPr>
          <a:xfrm>
            <a:off x="922949" y="1986920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1604622" y="1986920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899814" y="2504598"/>
            <a:ext cx="15472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itchFamily="34" charset="0"/>
                <a:cs typeface="Arial" pitchFamily="34" charset="0"/>
              </a:rPr>
              <a:t>l</a:t>
            </a:r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ow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 TGN1412 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 Box 14"/>
          <p:cNvSpPr txBox="1">
            <a:spLocks noChangeArrowheads="1"/>
          </p:cNvSpPr>
          <p:nvPr/>
        </p:nvSpPr>
        <p:spPr bwMode="auto">
          <a:xfrm>
            <a:off x="228315" y="401625"/>
            <a:ext cx="381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de-DE" sz="10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228315" y="238373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901451" y="535186"/>
            <a:ext cx="923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Herceptin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2785777" y="154543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2785777" y="11761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2785777" y="42951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60" name="Textfeld 59"/>
          <p:cNvSpPr txBox="1"/>
          <p:nvPr/>
        </p:nvSpPr>
        <p:spPr>
          <a:xfrm rot="16200000">
            <a:off x="2468633" y="1214720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/ml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2785777" y="8225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3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2427774" y="39900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3" name="Diagramm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9501720"/>
              </p:ext>
            </p:extLst>
          </p:nvPr>
        </p:nvGraphicFramePr>
        <p:xfrm>
          <a:off x="235847" y="2422497"/>
          <a:ext cx="2045559" cy="18817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4" name="Textfeld 63"/>
          <p:cNvSpPr txBox="1"/>
          <p:nvPr/>
        </p:nvSpPr>
        <p:spPr>
          <a:xfrm>
            <a:off x="2424060" y="238373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6" t="11235" b="27110"/>
          <a:stretch/>
        </p:blipFill>
        <p:spPr bwMode="auto">
          <a:xfrm>
            <a:off x="2975834" y="2383730"/>
            <a:ext cx="3187429" cy="1650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5" name="Textfeld 64"/>
          <p:cNvSpPr txBox="1"/>
          <p:nvPr/>
        </p:nvSpPr>
        <p:spPr>
          <a:xfrm>
            <a:off x="2774626" y="38301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2774626" y="336907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2774626" y="289616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2464919" y="3153113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de-DE" sz="800" dirty="0" smtClean="0">
                <a:latin typeface="Arial" pitchFamily="34" charset="0"/>
                <a:cs typeface="Arial" pitchFamily="34" charset="0"/>
              </a:rPr>
              <a:t>/ml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3208917" y="4162716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g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3941279" y="4162716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TNF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a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4727660" y="4162716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L-10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Gerade Verbindung 74"/>
          <p:cNvCxnSpPr/>
          <p:nvPr/>
        </p:nvCxnSpPr>
        <p:spPr>
          <a:xfrm>
            <a:off x="3147283" y="4168722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 Verbindung 75"/>
          <p:cNvCxnSpPr/>
          <p:nvPr/>
        </p:nvCxnSpPr>
        <p:spPr>
          <a:xfrm>
            <a:off x="3922926" y="4168722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 Verbindung 76"/>
          <p:cNvCxnSpPr/>
          <p:nvPr/>
        </p:nvCxnSpPr>
        <p:spPr>
          <a:xfrm>
            <a:off x="4688189" y="4168722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/>
          <p:cNvSpPr txBox="1"/>
          <p:nvPr/>
        </p:nvSpPr>
        <p:spPr>
          <a:xfrm>
            <a:off x="5518262" y="4162716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L-6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9" name="Gerade Verbindung 78"/>
          <p:cNvCxnSpPr/>
          <p:nvPr/>
        </p:nvCxnSpPr>
        <p:spPr>
          <a:xfrm>
            <a:off x="5431596" y="4168722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feld 85"/>
          <p:cNvSpPr txBox="1"/>
          <p:nvPr/>
        </p:nvSpPr>
        <p:spPr>
          <a:xfrm>
            <a:off x="919235" y="3966665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1604622" y="3966665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2974648" y="394739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3424453" y="3947399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3748339" y="394739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4188619" y="3947399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4514131" y="394739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4933145" y="3947399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5266556" y="3947399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5707944" y="3947399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-9810" y="0"/>
            <a:ext cx="63957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  <a:endParaRPr lang="de-DE" sz="14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986389" y="200274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414928" y="200274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3211794" y="2212868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g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3944156" y="2212868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TNF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a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4730537" y="2212868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L-10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Gerade Verbindung 36"/>
          <p:cNvCxnSpPr/>
          <p:nvPr/>
        </p:nvCxnSpPr>
        <p:spPr>
          <a:xfrm>
            <a:off x="3207310" y="2218874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37"/>
          <p:cNvCxnSpPr/>
          <p:nvPr/>
        </p:nvCxnSpPr>
        <p:spPr>
          <a:xfrm>
            <a:off x="3982953" y="2218874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38"/>
          <p:cNvCxnSpPr/>
          <p:nvPr/>
        </p:nvCxnSpPr>
        <p:spPr>
          <a:xfrm>
            <a:off x="4719641" y="2218874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5521139" y="221286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IL-6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Gerade Verbindung 42"/>
          <p:cNvCxnSpPr/>
          <p:nvPr/>
        </p:nvCxnSpPr>
        <p:spPr>
          <a:xfrm>
            <a:off x="5472573" y="2218874"/>
            <a:ext cx="5559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3738814" y="200274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4179094" y="200274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4515239" y="200274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934253" y="200274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278297" y="2002744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Arial" pitchFamily="34" charset="0"/>
                <a:cs typeface="Arial" pitchFamily="34" charset="0"/>
              </a:rPr>
              <a:t>before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5698419" y="2002744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after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785777" y="18868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2782063" y="24294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844485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ildschirmpräsentation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Paul Ehrlich 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ssmueller, Sabrina</dc:creator>
  <cp:lastModifiedBy>Waibler, Zoe</cp:lastModifiedBy>
  <cp:revision>123</cp:revision>
  <cp:lastPrinted>2013-02-04T12:04:47Z</cp:lastPrinted>
  <dcterms:created xsi:type="dcterms:W3CDTF">2012-03-07T16:00:40Z</dcterms:created>
  <dcterms:modified xsi:type="dcterms:W3CDTF">2016-02-01T08:17:15Z</dcterms:modified>
</cp:coreProperties>
</file>